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806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039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022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716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110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743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78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580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228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146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037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CF8BF0-71EA-46D4-BE39-623B07F8E0E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E5F48-CFEC-488B-8203-43B07689CE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060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28831" y="68267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S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" name="Picture 1" descr="SuppFig6_pc_to_penh3strains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342" y="693670"/>
            <a:ext cx="7439616" cy="54106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558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660478" y="109182"/>
            <a:ext cx="891198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8. Baseline and Final Penh by founder haplotype for mice with A/J, C57BL/6J, or 129S1/</a:t>
            </a:r>
            <a:r>
              <a:rPr lang="en-US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vImJ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founder haplotypes. For the sake of clarity, x-axis values have been shifted to make the data points easier to visualize.</a:t>
            </a:r>
          </a:p>
        </p:txBody>
      </p:sp>
    </p:spTree>
    <p:extLst>
      <p:ext uri="{BB962C8B-B14F-4D97-AF65-F5344CB8AC3E}">
        <p14:creationId xmlns:p14="http://schemas.microsoft.com/office/powerpoint/2010/main" val="2752580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lper</dc:creator>
  <cp:lastModifiedBy>Sarah Wolper</cp:lastModifiedBy>
  <cp:revision>1</cp:revision>
  <dcterms:created xsi:type="dcterms:W3CDTF">2016-07-20T19:39:37Z</dcterms:created>
  <dcterms:modified xsi:type="dcterms:W3CDTF">2016-07-20T19:39:46Z</dcterms:modified>
</cp:coreProperties>
</file>